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3" d="100"/>
          <a:sy n="73" d="100"/>
        </p:scale>
        <p:origin x="-546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EE5EE7E8-5921-42AA-BA72-625E634245D9}" type="datetimeFigureOut">
              <a:rPr lang="en-US" smtClean="0"/>
              <a:t>3/20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1E7771C9-E08C-40F4-9724-015BAAF485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95061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8241" name="Slide Image Placeholder 1"/>
          <p:cNvSpPr>
            <a:spLocks noGrp="1" noRot="1" noChangeAspec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38242" name="Notes Placeholder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US" smtClean="0"/>
          </a:p>
        </p:txBody>
      </p:sp>
      <p:sp>
        <p:nvSpPr>
          <p:cNvPr id="119811" name="Slide Number Placeholder 3"/>
          <p:cNvSpPr>
            <a:spLocks noGrp="1"/>
          </p:cNvSpPr>
          <p:nvPr>
            <p:ph type="sldNum" sz="quarter" idx="5"/>
          </p:nvPr>
        </p:nvSpPr>
        <p:spPr bwMode="auto"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>
              <a:defRPr/>
            </a:pPr>
            <a:fld id="{29941D19-A786-4C7E-ADF6-CA43C981C48A}" type="slidenum">
              <a:rPr lang="en-US">
                <a:solidFill>
                  <a:prstClr val="black"/>
                </a:solidFill>
              </a:rPr>
              <a:pPr>
                <a:defRPr/>
              </a:pPr>
              <a:t>1</a:t>
            </a:fld>
            <a:endParaRPr lang="en-US">
              <a:solidFill>
                <a:prstClr val="black"/>
              </a:solidFill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489EF16-D883-4149-A5BB-0A44773E595E}" type="datetimeFigureOut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3/20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991E75-1701-4C9A-AD54-F83DF1C47EF6}" type="slidenum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10867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7F22066-7072-46F0-BF8B-FDAA238B1C14}" type="datetimeFigureOut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3/20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014618C-917B-4931-BDF9-C51CEBB6AC3B}" type="slidenum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503828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FA2CB31-5CF3-4782-9D29-9CE1F4D97F68}" type="datetimeFigureOut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3/20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689F1C-9D22-423B-A325-D195C90B6967}" type="slidenum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020734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2C89ABC-25B4-468C-AB79-A3A761BAFAB2}" type="datetimeFigureOut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3/20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8E735D0-9D98-4FD3-AC50-FA654F0A64CE}" type="slidenum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759922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7330BB-1581-4598-A3FC-FF629F83BAA5}" type="datetimeFigureOut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3/20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F83DC4D-2652-43F7-9C62-C06ED42E9D37}" type="slidenum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234338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987C9E1-239E-4820-8575-C49AD7A2472F}" type="datetimeFigureOut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3/20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673ECF0-49CF-47DA-A3CC-2F827C5F6D64}" type="slidenum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270729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A807EF1-5EA1-43D3-8CD0-E88D7C438F19}" type="datetimeFigureOut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3/20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216F4D6-C3C0-4CD9-8C98-C64F8E06F4C9}" type="slidenum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006323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6076EE-010B-4B87-B858-556F79A83D22}" type="datetimeFigureOut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3/20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6FC6AC6-E13B-47B7-8A68-A10E9511B956}" type="slidenum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819989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B1E93BB-1F0D-4C78-BE08-44064C7A7A8F}" type="datetimeFigureOut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3/20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735CC9D-5242-4DE1-A57E-174AA4B78409}" type="slidenum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479669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0F40509-5F19-4D6E-8D48-269F6DDEA75F}" type="datetimeFigureOut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3/20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49AF692-6C0B-4830-BBD3-7FA185405628}" type="slidenum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930095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F12019-90A3-49EB-B3E5-BE67B3FF8A7C}" type="datetimeFigureOut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3/20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73F592A-BBA0-4338-B06E-0C015A73FDB2}" type="slidenum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377052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6F0A6AC8-605E-401A-901F-D4C920C71860}" type="datetimeFigureOut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3/20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FA84843E-DD56-4EC0-BF03-D9BF00915E85}" type="slidenum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716355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221" name="Text Box 11"/>
          <p:cNvSpPr txBox="1">
            <a:spLocks noChangeArrowheads="1"/>
          </p:cNvSpPr>
          <p:nvPr/>
        </p:nvSpPr>
        <p:spPr bwMode="auto">
          <a:xfrm>
            <a:off x="381000" y="560437"/>
            <a:ext cx="1067793" cy="35394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700" b="1" smtClean="0">
                <a:solidFill>
                  <a:prstClr val="black"/>
                </a:solidFill>
              </a:rPr>
              <a:t>S1 </a:t>
            </a:r>
            <a:r>
              <a:rPr lang="en-US" sz="1700" b="1" dirty="0" smtClean="0">
                <a:solidFill>
                  <a:prstClr val="black"/>
                </a:solidFill>
              </a:rPr>
              <a:t>Table</a:t>
            </a:r>
            <a:endParaRPr lang="en-US" sz="1700" b="1" dirty="0">
              <a:solidFill>
                <a:prstClr val="black"/>
              </a:solidFill>
            </a:endParaRP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05710403"/>
              </p:ext>
            </p:extLst>
          </p:nvPr>
        </p:nvGraphicFramePr>
        <p:xfrm>
          <a:off x="380999" y="990588"/>
          <a:ext cx="8305801" cy="480061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65067"/>
                <a:gridCol w="1182044"/>
                <a:gridCol w="1065778"/>
                <a:gridCol w="3827111"/>
                <a:gridCol w="465067"/>
                <a:gridCol w="465067"/>
                <a:gridCol w="835667"/>
              </a:tblGrid>
              <a:tr h="363468"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Accession Number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Gene ID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Name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Mass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 err="1" smtClean="0">
                          <a:effectLst/>
                          <a:latin typeface="+mn-lt"/>
                        </a:rPr>
                        <a:t>MascotScor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Queries matched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</a:tr>
              <a:tr h="1859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CAA2644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2942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bcr</a:t>
                      </a:r>
                      <a:endParaRPr lang="en-US" sz="1000" b="1" i="0" u="none" strike="noStrike">
                        <a:solidFill>
                          <a:srgbClr val="FF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142717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5633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606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</a:tr>
              <a:tr h="1859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2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NP_001006635.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54860079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rho GTPase-activating protein 17 isoform 1 [Homo sapiens]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95377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1360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158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</a:tr>
              <a:tr h="1859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3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NP_060524.4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54860105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rho GTPase-activating protein 17 isoform 2 [Homo sapiens]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87554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1003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123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</a:tr>
              <a:tr h="363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3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AAD42876.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5360115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NY-REN-45 antigen (potassium channel tetramerization domain containing 3, KCTD2)</a:t>
                      </a:r>
                      <a:endParaRPr lang="en-US" sz="1000" b="1" i="0" u="none" strike="noStrike">
                        <a:solidFill>
                          <a:srgbClr val="00B0F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effectLst/>
                          <a:latin typeface="+mn-lt"/>
                        </a:rPr>
                        <a:t>89012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876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124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</a:tr>
              <a:tr h="1859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5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NP_055845.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11987420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furry-like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339383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312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7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</a:tr>
              <a:tr h="1859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6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EAW89969.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119610375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KIAA0672 gene product, isoform CRA_e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80590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263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20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</a:tr>
              <a:tr h="1859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7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EAW93065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11961347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hCG1755809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161232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253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60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</a:tr>
              <a:tr h="1859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9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EAW56981.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119577385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u="none" strike="noStrike">
                          <a:effectLst/>
                          <a:latin typeface="+mn-lt"/>
                        </a:rPr>
                        <a:t>SH3KBP1 binding protein 1 isoform CRA_c</a:t>
                      </a:r>
                      <a:endParaRPr lang="de-DE" sz="1000" b="1" i="0" u="none" strike="noStrike">
                        <a:solidFill>
                          <a:srgbClr val="00B05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7366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197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22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</a:tr>
              <a:tr h="1859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10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EAW73936.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119594339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damage-specific DNA binding protein 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12137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172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14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</a:tr>
              <a:tr h="1859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1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BAG59708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194386288  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unnamed protein product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101054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172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10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</a:tr>
              <a:tr h="363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12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CAG33049.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48145653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b="1" u="none" strike="noStrike">
                          <a:effectLst/>
                          <a:latin typeface="+mn-lt"/>
                        </a:rPr>
                        <a:t>PECI, (Peroxisomal 3,2-trans-enoyl-CoA isomerase; Dodecenoyl-CoA isomerase)</a:t>
                      </a:r>
                      <a:endParaRPr lang="pt-BR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39584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2463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152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</a:tr>
              <a:tr h="1859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13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AAF68974.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7739706  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effectLst/>
                          <a:latin typeface="+mn-lt"/>
                        </a:rPr>
                        <a:t>hepatocellular carcinoma-associated antigen 64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21575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2257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12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</a:tr>
              <a:tr h="1859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14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BAD97085.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62898291  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ubiquitous mitochondrial creatine kinase precursor variant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46935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213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204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</a:tr>
              <a:tr h="1859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15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NP_005460.2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34577075 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acyl-coenzyme A thioesterase 8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3589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289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25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</a:tr>
              <a:tr h="363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16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AAA60561.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338237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000" b="1" u="none" strike="noStrike" dirty="0" err="1">
                          <a:effectLst/>
                          <a:latin typeface="+mn-lt"/>
                        </a:rPr>
                        <a:t>sarcomeric</a:t>
                      </a:r>
                      <a:r>
                        <a:rPr lang="es-ES" sz="1000" b="1" u="none" strike="noStrike" dirty="0">
                          <a:effectLst/>
                          <a:latin typeface="+mn-lt"/>
                        </a:rPr>
                        <a:t> </a:t>
                      </a:r>
                      <a:r>
                        <a:rPr lang="es-ES" sz="1000" b="1" u="none" strike="noStrike" dirty="0" err="1">
                          <a:effectLst/>
                          <a:latin typeface="+mn-lt"/>
                        </a:rPr>
                        <a:t>mitochondrial</a:t>
                      </a:r>
                      <a:r>
                        <a:rPr lang="es-ES" sz="1000" b="1" u="none" strike="noStrike" dirty="0">
                          <a:effectLst/>
                          <a:latin typeface="+mn-lt"/>
                        </a:rPr>
                        <a:t> </a:t>
                      </a:r>
                      <a:r>
                        <a:rPr lang="es-ES" sz="1000" b="1" u="none" strike="noStrike" dirty="0" err="1">
                          <a:effectLst/>
                          <a:latin typeface="+mn-lt"/>
                        </a:rPr>
                        <a:t>creatine</a:t>
                      </a:r>
                      <a:r>
                        <a:rPr lang="es-ES" sz="1000" b="1" u="none" strike="noStrike" dirty="0">
                          <a:effectLst/>
                          <a:latin typeface="+mn-lt"/>
                        </a:rPr>
                        <a:t> </a:t>
                      </a:r>
                      <a:r>
                        <a:rPr lang="es-ES" sz="1000" b="1" u="none" strike="noStrike" dirty="0" err="1">
                          <a:effectLst/>
                          <a:latin typeface="+mn-lt"/>
                        </a:rPr>
                        <a:t>kinase</a:t>
                      </a:r>
                      <a:r>
                        <a:rPr lang="es-ES" sz="1000" b="1" u="none" strike="noStrike" dirty="0">
                          <a:effectLst/>
                          <a:latin typeface="+mn-lt"/>
                        </a:rPr>
                        <a:t> precursor (EC 2.7.3.2)</a:t>
                      </a:r>
                      <a:endParaRPr lang="es-ES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47490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235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85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</a:tr>
              <a:tr h="1859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17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AAH08633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1425040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actin, beta</a:t>
                      </a:r>
                      <a:endParaRPr lang="en-US" sz="1000" b="1" i="0" u="none" strike="noStrike">
                        <a:solidFill>
                          <a:srgbClr val="7030A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40978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232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18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</a:tr>
              <a:tr h="1859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18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NP_001886.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4503095  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casein kinase II alpha 1 subunit isoform a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45115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223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16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</a:tr>
              <a:tr h="1859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19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NP_004829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224809408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u="none" strike="noStrike">
                          <a:effectLst/>
                          <a:latin typeface="+mn-lt"/>
                        </a:rPr>
                        <a:t>homer protein homolog 3 isoform 1</a:t>
                      </a:r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3988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165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17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</a:tr>
              <a:tr h="1859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20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AAH07753.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14043538  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000" b="1" u="none" strike="noStrike">
                          <a:effectLst/>
                          <a:latin typeface="+mn-lt"/>
                        </a:rPr>
                        <a:t>MYLK2 protein (Myosin Light Chain Kinase 2)</a:t>
                      </a:r>
                      <a:endParaRPr lang="fi-FI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27580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155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16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</a:tr>
              <a:tr h="1859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2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AAH31038.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21410256  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KCTD17 protein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34767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39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17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</a:tr>
              <a:tr h="1859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22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NP_002291.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4557032 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L-lactate dehydrogenase B</a:t>
                      </a:r>
                      <a:endParaRPr lang="en-US" sz="1000" b="1" i="0" u="none" strike="noStrike">
                        <a:solidFill>
                          <a:srgbClr val="F79646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36615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+mn-lt"/>
                        </a:rPr>
                        <a:t>249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effectLst/>
                          <a:latin typeface="+mn-lt"/>
                        </a:rPr>
                        <a:t>77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2" marR="7202" marT="7202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99598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Custom 1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5</TotalTime>
  <Words>238</Words>
  <Application>Microsoft Office PowerPoint</Application>
  <PresentationFormat>On-screen Show (4:3)</PresentationFormat>
  <Paragraphs>155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1_Office Theme</vt:lpstr>
      <vt:lpstr>PowerPoint Presentation</vt:lpstr>
    </vt:vector>
  </TitlesOfParts>
  <Company>UT Southwestern Medical Cen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ieko Mineo</dc:creator>
  <cp:lastModifiedBy>Chieko Mineo</cp:lastModifiedBy>
  <cp:revision>12</cp:revision>
  <cp:lastPrinted>2014-07-09T18:15:17Z</cp:lastPrinted>
  <dcterms:created xsi:type="dcterms:W3CDTF">2014-06-05T14:22:14Z</dcterms:created>
  <dcterms:modified xsi:type="dcterms:W3CDTF">2015-03-20T14:18:13Z</dcterms:modified>
</cp:coreProperties>
</file>